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2598" y="357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0-Nov-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0-Nov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583631" y="4386855"/>
            <a:ext cx="2103895" cy="78615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47731" y="4038599"/>
            <a:ext cx="1112520" cy="156057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mage-derived and physiological markers to predict adequate adenosine-induced hyperemic response in Rubidium-82 myocardial perfusion imaging 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4478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rtin Lyngby Lassen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ads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issenber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hD, Christina Byrne, M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aji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heykhzad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reete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Kapish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Hurry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ne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ibek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chmedes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reas Kjær, MD, Ph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hilip Hasbak, M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US" sz="105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linical Physiology, Nuclear Medicine &amp; PET and Cluster for Molecular Imaging, Department of Biomedical Sciences, 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igshospitale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University of Copenhagen, </a:t>
            </a:r>
            <a:r>
              <a:rPr lang="en-US" sz="105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ardiology, Copenhagen University Hospital, Gentofte, Denmark, </a:t>
            </a:r>
            <a:r>
              <a:rPr lang="en-US" sz="105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Drug Design and Pharmacology, Faculty of Health and Medical Sciences, University of Copenhagen, Copenhagen, Denmark, </a:t>
            </a:r>
            <a:r>
              <a:rPr lang="en-US" sz="105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Biochemistry and Immunology, 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illebaelt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Hospital, 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ejle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Denmark</a:t>
            </a:r>
          </a:p>
          <a:p>
            <a:endParaRPr lang="en-US" altLang="en-US" sz="28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5E7A369B-A790-452E-AD0E-B292E51673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3115" y="4500662"/>
            <a:ext cx="1924929" cy="558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A person wearing a white shirt&#10;&#10;Description automatically generated with low confidence">
            <a:extLst>
              <a:ext uri="{FF2B5EF4-FFF2-40B4-BE49-F238E27FC236}">
                <a16:creationId xmlns:a16="http://schemas.microsoft.com/office/drawing/2014/main" id="{F482D453-B801-4213-BB53-A362B61DA2D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731" y="4038600"/>
            <a:ext cx="1112520" cy="1560576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Adequate hyperemic response is required for accurate myocardial perfusion assessments</a:t>
            </a:r>
          </a:p>
          <a:p>
            <a:pPr marL="0" indent="0">
              <a:buNone/>
            </a:pPr>
            <a:r>
              <a:rPr lang="en-US" altLang="en-US" sz="2000" dirty="0"/>
              <a:t>2- The hyperemic response may be affected by several factors, hereunder caffeine consumption before stress myocardial perfusion imaging</a:t>
            </a:r>
          </a:p>
          <a:p>
            <a:pPr marL="0" indent="0">
              <a:buNone/>
            </a:pPr>
            <a:r>
              <a:rPr lang="en-US" altLang="en-US" sz="2000" dirty="0"/>
              <a:t>3- Several markers including physiological, image-derived and hybrid markers have been suggested to identify the adequate response; however, they have not been cross-validated in a controlled setting </a:t>
            </a:r>
          </a:p>
          <a:p>
            <a:pPr marL="0" indent="0">
              <a:buNone/>
            </a:pPr>
            <a:r>
              <a:rPr lang="en-US" altLang="en-US" sz="2000" dirty="0"/>
              <a:t>4- This study aimed to cross-validate seven markers and their affinity to detect adequate hyperemic response in a cohort of healthy volunteers who underwent rest/stress myocardial perfusion imaging with and without controlled caffeine consumption prior to the scan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1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- Seven markers were evaluated in this study, stratified by the plasma caffeine concentration (PCC)</a:t>
            </a: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1F51876-FF96-4C26-A480-074FC05BF4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3347041"/>
              </p:ext>
            </p:extLst>
          </p:nvPr>
        </p:nvGraphicFramePr>
        <p:xfrm>
          <a:off x="1553210" y="2479403"/>
          <a:ext cx="6113780" cy="330816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697480">
                  <a:extLst>
                    <a:ext uri="{9D8B030D-6E8A-4147-A177-3AD203B41FA5}">
                      <a16:colId xmlns:a16="http://schemas.microsoft.com/office/drawing/2014/main" val="1312388634"/>
                    </a:ext>
                  </a:extLst>
                </a:gridCol>
                <a:gridCol w="1377950">
                  <a:extLst>
                    <a:ext uri="{9D8B030D-6E8A-4147-A177-3AD203B41FA5}">
                      <a16:colId xmlns:a16="http://schemas.microsoft.com/office/drawing/2014/main" val="3200739222"/>
                    </a:ext>
                  </a:extLst>
                </a:gridCol>
                <a:gridCol w="2038350">
                  <a:extLst>
                    <a:ext uri="{9D8B030D-6E8A-4147-A177-3AD203B41FA5}">
                      <a16:colId xmlns:a16="http://schemas.microsoft.com/office/drawing/2014/main" val="119616006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PCC &lt;1.0mg/l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PCC ≥ 1.0mg/l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49911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Number of subjects (MPI sessions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38 (63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39 (66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486997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Myocardial Flow Reserv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3.80±0.8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3.39±1.21 (p=0.027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80219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PCC (mg/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2±0.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5.9±4.2 (p&lt;0.001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61991159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Stress marker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22440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Splenic Response Ratio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59±0.1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0.70±0.16  (p&lt;0.001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21148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Splenic stress-to-rest Intensity Ratio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70±0.1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75±0.14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127726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da-DK" sz="1100" dirty="0">
                          <a:effectLst/>
                        </a:rPr>
                        <a:t>Rest-to-stress </a:t>
                      </a:r>
                      <a:r>
                        <a:rPr lang="da-DK" sz="1100" dirty="0" err="1">
                          <a:effectLst/>
                        </a:rPr>
                        <a:t>change</a:t>
                      </a:r>
                      <a:r>
                        <a:rPr lang="da-DK" sz="1100" dirty="0">
                          <a:effectLst/>
                        </a:rPr>
                        <a:t> in </a:t>
                      </a:r>
                      <a:r>
                        <a:rPr lang="da-DK" sz="1100" dirty="0" err="1">
                          <a:effectLst/>
                        </a:rPr>
                        <a:t>heart</a:t>
                      </a:r>
                      <a:r>
                        <a:rPr lang="da-DK" sz="1100" dirty="0">
                          <a:effectLst/>
                        </a:rPr>
                        <a:t> rat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29±1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effectLst/>
                        </a:rPr>
                        <a:t>46±38 (p&lt;0.001)</a:t>
                      </a:r>
                      <a:endParaRPr lang="en-US" sz="12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786990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da-DK" sz="1100" dirty="0">
                          <a:effectLst/>
                        </a:rPr>
                        <a:t>Rest-to-stress %-</a:t>
                      </a:r>
                      <a:r>
                        <a:rPr lang="da-DK" sz="1100" dirty="0" err="1">
                          <a:effectLst/>
                        </a:rPr>
                        <a:t>change</a:t>
                      </a:r>
                      <a:r>
                        <a:rPr lang="da-DK" sz="1100" dirty="0">
                          <a:effectLst/>
                        </a:rPr>
                        <a:t> in </a:t>
                      </a:r>
                      <a:r>
                        <a:rPr lang="da-DK" sz="1100" dirty="0" err="1">
                          <a:effectLst/>
                        </a:rPr>
                        <a:t>heart</a:t>
                      </a:r>
                      <a:r>
                        <a:rPr lang="da-DK" sz="1100" dirty="0">
                          <a:effectLst/>
                        </a:rPr>
                        <a:t> rat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44±2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23±37 (p=0.001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90811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a-DK" sz="1100" dirty="0">
                          <a:effectLst/>
                        </a:rPr>
                        <a:t>Rest-to-stress </a:t>
                      </a:r>
                      <a:r>
                        <a:rPr lang="da-DK" sz="1100" dirty="0" err="1">
                          <a:effectLst/>
                        </a:rPr>
                        <a:t>change</a:t>
                      </a:r>
                      <a:r>
                        <a:rPr lang="da-DK" sz="1100" dirty="0">
                          <a:effectLst/>
                        </a:rPr>
                        <a:t> in RPP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3,091±1,73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1,075±5,080 (p=0.003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73038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da-DK" sz="1100" dirty="0">
                          <a:effectLst/>
                        </a:rPr>
                        <a:t>Rest-to-stress </a:t>
                      </a:r>
                      <a:r>
                        <a:rPr lang="da-DK" sz="1100" dirty="0" err="1">
                          <a:effectLst/>
                        </a:rPr>
                        <a:t>change</a:t>
                      </a:r>
                      <a:r>
                        <a:rPr lang="da-DK" sz="1100" dirty="0">
                          <a:effectLst/>
                        </a:rPr>
                        <a:t> in SBP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49±1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effectLst/>
                        </a:rPr>
                        <a:t>2±14 (p&lt;0.001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18410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da-DK" sz="1100" dirty="0">
                          <a:effectLst/>
                        </a:rPr>
                        <a:t>Rest-to-stress </a:t>
                      </a:r>
                      <a:r>
                        <a:rPr lang="da-DK" sz="1100" dirty="0" err="1">
                          <a:effectLst/>
                        </a:rPr>
                        <a:t>change</a:t>
                      </a:r>
                      <a:r>
                        <a:rPr lang="da-DK" sz="1100" dirty="0">
                          <a:effectLst/>
                        </a:rPr>
                        <a:t> in </a:t>
                      </a:r>
                      <a:r>
                        <a:rPr lang="en-US" sz="1100" dirty="0">
                          <a:effectLst/>
                        </a:rPr>
                        <a:t>CVR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69±26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62±3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307109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2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1- Performance measures of the 7 markers</a:t>
            </a: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64BF679-0B84-4DE6-8BF3-F69C93DAF5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2083357"/>
            <a:ext cx="4886642" cy="360092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2A42DF-23F1-49AB-B4BF-ECA955F5EED6}"/>
              </a:ext>
            </a:extLst>
          </p:cNvPr>
          <p:cNvSpPr txBox="1"/>
          <p:nvPr/>
        </p:nvSpPr>
        <p:spPr>
          <a:xfrm>
            <a:off x="5347924" y="2083356"/>
            <a:ext cx="3262676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erformance measures for the seven markers used for identification of adequate stressing of the volunteers.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ensitivity and specificity for the data obtained with PCC&lt;1.0 and PCC≥1.0mg/l are shown in a and b, respectively. The grouped measures (PCC &lt; 1.0 and PCC ≥ 1.0mg/l) are shown in c). PPV and NPV are shown for the datasets with PCC&lt;1.0mg/L and PCC≥1.0mg/l in d and e, respectively. In f, the NPV and PPV are shown for the grouped measures (PCC &lt; 1.0 and PCC ≥ 1.0mg/l). </a:t>
            </a:r>
            <a:endParaRPr lang="LID4096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n a cohort of young, healthy individuals, all image-derived, and physiological markers provided acceptable sensitivities and specificities when the subjects followed the guideline-recommended caffeine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ausation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before MPI. Nevertheless, their use warrants great care when caffeine consumption prior to MPI cannot be ruled </a:t>
            </a:r>
            <a:r>
              <a:rPr lang="en-US" sz="180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ut.</a:t>
            </a:r>
            <a:endParaRPr lang="en-US" sz="18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Words>653</Words>
  <Application>Microsoft Office PowerPoint</Application>
  <PresentationFormat>On-screen Show (4:3)</PresentationFormat>
  <Paragraphs>5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Image-derived and physiological markers to predict adequate adenosine-induced hyperemic response in Rubidium-82 myocardial perfusion imaging </vt:lpstr>
      <vt:lpstr>BACKGROUND</vt:lpstr>
      <vt:lpstr>Summary- 1</vt:lpstr>
      <vt:lpstr>Summary- 2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rtin Lassen</cp:lastModifiedBy>
  <cp:revision>104</cp:revision>
  <dcterms:created xsi:type="dcterms:W3CDTF">2011-04-18T21:44:13Z</dcterms:created>
  <dcterms:modified xsi:type="dcterms:W3CDTF">2021-11-30T09:21:26Z</dcterms:modified>
</cp:coreProperties>
</file>